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D35C645-160A-4A95-9E77-3D7B8EA179D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B089DCD-1C46-46E8-B9C8-B373F3DDDCA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68AAC18-50F4-421B-A673-03F499E3BCC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CB75C5F-918E-427A-B9B9-7642885214D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CB6BA3D-8351-4A4F-8B2E-E5CC6710ED2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9B6F94C-31B6-4AE5-AFD7-93F912783C5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C6AF691-B15F-42E9-B1DE-23470F1710C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5771229-6DBC-41AF-81FB-C97464F931C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57E3120-7F51-4796-AFA3-22DF409F0C8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EE30003-172F-43AE-8C3A-2C79D57BCA8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C856D5E-C3B2-474F-95C4-EA6AB0BA04D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62DA044-6C8F-4E4A-937C-90021BFD7E8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0D1558E-D3C9-4303-9DA7-17CC5C1E2B21}"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Object 1" descr=""/>
          <p:cNvPicPr/>
          <p:nvPr/>
        </p:nvPicPr>
        <p:blipFill>
          <a:blip r:embed="rId1"/>
          <a:stretch/>
        </p:blipFill>
        <p:spPr>
          <a:xfrm>
            <a:off x="584280" y="307800"/>
            <a:ext cx="5551560" cy="4338720"/>
          </a:xfrm>
          <a:prstGeom prst="rect">
            <a:avLst/>
          </a:prstGeom>
          <a:ln w="0">
            <a:noFill/>
          </a:ln>
        </p:spPr>
      </p:pic>
      <p:sp>
        <p:nvSpPr>
          <p:cNvPr id="42" name="Rectangle 2"/>
          <p:cNvSpPr/>
          <p:nvPr/>
        </p:nvSpPr>
        <p:spPr>
          <a:xfrm>
            <a:off x="762120" y="4952880"/>
            <a:ext cx="5562360" cy="8240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ea typeface="Times New Roman"/>
              </a:rPr>
              <a:t>Figure S1.</a:t>
            </a:r>
            <a:r>
              <a:rPr b="0" lang="en-IN" sz="1200" spc="-1" strike="noStrike">
                <a:solidFill>
                  <a:srgbClr val="000000"/>
                </a:solidFill>
                <a:latin typeface="Times New Roman"/>
                <a:ea typeface="Times New Roman"/>
              </a:rPr>
              <a:t> The full-length cDNA and the deduced amino acid sequence of SbSLSP. The start codon ATG and the stop codon TGA are mentioned by green and red colour, respectively. The 5′ and 3′-UTR region are mentioned in blue color. Green highlighted region indicates the N-myristoylation site.</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16T00:00:00Z</dcterms:created>
  <dc:creator>avinashstud1</dc:creator>
  <dc:description/>
  <dc:language>en-US</dc:language>
  <cp:lastModifiedBy>user</cp:lastModifiedBy>
  <dcterms:modified xsi:type="dcterms:W3CDTF">2016-03-17T21:21:09Z</dcterms:modified>
  <cp:revision>13</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DocumentId">
    <vt:lpwstr>Presentation 1.PPT</vt:lpwstr>
  </property>
  <property fmtid="{D5CDD505-2E9C-101B-9397-08002B2CF9AE}" pid="3" name="DocumentType">
    <vt:lpwstr>Presentation</vt:lpwstr>
  </property>
  <property fmtid="{D5CDD505-2E9C-101B-9397-08002B2CF9AE}" pid="4" name="FileFormat">
    <vt:lpwstr>PPT</vt:lpwstr>
  </property>
  <property fmtid="{D5CDD505-2E9C-101B-9397-08002B2CF9AE}" pid="5" name="TitleName">
    <vt:lpwstr>Presentation 1.PPT</vt:lpwstr>
  </property>
</Properties>
</file>